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6"/>
  </p:notesMasterIdLst>
  <p:sldIdLst>
    <p:sldId id="277" r:id="rId2"/>
    <p:sldId id="264" r:id="rId3"/>
    <p:sldId id="265" r:id="rId4"/>
    <p:sldId id="266" r:id="rId5"/>
    <p:sldId id="267" r:id="rId6"/>
    <p:sldId id="268" r:id="rId7"/>
    <p:sldId id="270" r:id="rId8"/>
    <p:sldId id="272" r:id="rId9"/>
    <p:sldId id="274" r:id="rId10"/>
    <p:sldId id="278" r:id="rId11"/>
    <p:sldId id="275" r:id="rId12"/>
    <p:sldId id="276" r:id="rId13"/>
    <p:sldId id="279" r:id="rId14"/>
    <p:sldId id="280" r:id="rId1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4" autoAdjust="0"/>
    <p:restoredTop sz="94660"/>
  </p:normalViewPr>
  <p:slideViewPr>
    <p:cSldViewPr>
      <p:cViewPr varScale="1">
        <p:scale>
          <a:sx n="66" d="100"/>
          <a:sy n="66" d="100"/>
        </p:scale>
        <p:origin x="-1488" y="-102"/>
      </p:cViewPr>
      <p:guideLst>
        <p:guide orient="horz" pos="2160"/>
        <p:guide pos="286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80197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0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upplementary for Western Blot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699852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434975" y="2299905"/>
            <a:ext cx="8229600" cy="1143000"/>
          </a:xfrm>
        </p:spPr>
        <p:txBody>
          <a:bodyPr/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upplementary for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Methods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319952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3528" y="255994"/>
            <a:ext cx="8231137" cy="60016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Methods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Supplement</a:t>
            </a:r>
          </a:p>
          <a:p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 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LC-MS/MS Analysis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tryptic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peptides were dissolved in 0.1% formic acid (solvent A), directly loaded onto a home-made reversed-phase analytical column. The gradient was comprised of an increase from 7% to 25% solvent B (0.1% formic acid in 90% acetonitrile) over 40 min, 25% to 36% in 12 min and climbing to 80% in 4 min then holding at 80% for the last 4 min, all at a constant flow rate of 400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nL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/min on an EASY-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nLC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1000 UPLC system. The peptides were subjected to NSI source followed by tandem mass spectrometry (MS/MS) in Q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ExactiveTM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Plus (Thermo) coupled online to the UPLC. The electrospray voltage applied was 2.0 kV. The m/z scan range was 350 to 1150 for full scan, and intact peptides were detected in the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Orbitra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at a resolution of 70,000. Peptides were then selected for MS/MS using NCE setting as 27 and the fragments were detected in the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Orbitra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at a resolution of 17,500. A data-independent procedure that alternated between one MS scan followed by 20 MS/MS scans. Automatic gain control (AGC) was set at 3E6 for full MS and 1E5 for MS/MS. The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maxumum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IT was set at 50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ms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for full MS and 130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ms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for MS/MS. The isolation window for MS/MS was set at 1.6 m/z. The peptide was identified by its second-order spectrum and quantified by its intensity. FDR was adjusted to &lt; 1% and minimum score for modified peptides was set &gt; 40.And The mass error</a:t>
            </a:r>
            <a:r>
              <a:rPr lang="zh-CN" altLang="zh-CN" dirty="0">
                <a:latin typeface="Times New Roman" pitchFamily="18" charset="0"/>
                <a:cs typeface="Times New Roman" pitchFamily="18" charset="0"/>
              </a:rPr>
              <a:t>（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ppm</a:t>
            </a:r>
            <a:r>
              <a:rPr lang="zh-CN" altLang="zh-CN" dirty="0">
                <a:latin typeface="Times New Roman" pitchFamily="18" charset="0"/>
                <a:cs typeface="Times New Roman" pitchFamily="18" charset="0"/>
              </a:rPr>
              <a:t>）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need to be within </a:t>
            </a:r>
            <a:r>
              <a:rPr lang="zh-CN" altLang="zh-CN" dirty="0">
                <a:latin typeface="Times New Roman" pitchFamily="18" charset="0"/>
                <a:cs typeface="Times New Roman" pitchFamily="18" charset="0"/>
              </a:rPr>
              <a:t>±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10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397436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492763" y="980728"/>
            <a:ext cx="7560840" cy="36933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Methods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Supplement</a:t>
            </a:r>
          </a:p>
          <a:p>
            <a:endParaRPr lang="en-US" altLang="zh-CN" sz="2400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zh-CN" sz="2400" dirty="0">
              <a:latin typeface="Times New Roman" pitchFamily="18" charset="0"/>
              <a:cs typeface="Times New Roman" pitchFamily="18" charset="0"/>
            </a:endParaRPr>
          </a:p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Data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Analysis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The resulting MS data were processed using Skyline (v.3.6). Peptide settings: enzyme was set as Trypsin [KR/P], Max missed cleavage set as 0. The peptide length was set as 7-25, Variable modification was set as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Carbamidomethyl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on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Cys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. Transition settings: precursor charges were set as 2, 3, ion charges were set as 1, ion types were set as b, y. The product ions were set as from ion 3 to last ion, the ion match tolerance was set as 0.02 Da.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/>
              <a:t> 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240648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71472" y="1928802"/>
            <a:ext cx="8229600" cy="1143000"/>
          </a:xfrm>
        </p:spPr>
        <p:txBody>
          <a:bodyPr/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upplementary for PRM</a:t>
            </a:r>
            <a:endParaRPr lang="zh-CN" altLang="en-US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dministrator\Desktop\图片1.ti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85720" y="1714488"/>
            <a:ext cx="8606760" cy="2357454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627832"/>
            <a:ext cx="8598420" cy="56448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023689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783" y="464964"/>
            <a:ext cx="8471062" cy="59153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271311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866" y="244397"/>
            <a:ext cx="8632423" cy="62809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694642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402678" y="2060953"/>
            <a:ext cx="816610" cy="3672596"/>
            <a:chOff x="107" y="2964"/>
            <a:chExt cx="1286" cy="3164"/>
          </a:xfrm>
        </p:grpSpPr>
        <p:grpSp>
          <p:nvGrpSpPr>
            <p:cNvPr id="5" name="组合 4"/>
            <p:cNvGrpSpPr/>
            <p:nvPr/>
          </p:nvGrpSpPr>
          <p:grpSpPr>
            <a:xfrm>
              <a:off x="199" y="5645"/>
              <a:ext cx="1134" cy="483"/>
              <a:chOff x="186" y="8833"/>
              <a:chExt cx="1134" cy="534"/>
            </a:xfrm>
          </p:grpSpPr>
          <p:cxnSp>
            <p:nvCxnSpPr>
              <p:cNvPr id="30" name="直接箭头连接符 29"/>
              <p:cNvCxnSpPr/>
              <p:nvPr/>
            </p:nvCxnSpPr>
            <p:spPr>
              <a:xfrm>
                <a:off x="720" y="8962"/>
                <a:ext cx="600" cy="0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" name="文本框 50"/>
              <p:cNvSpPr txBox="1"/>
              <p:nvPr/>
            </p:nvSpPr>
            <p:spPr>
              <a:xfrm>
                <a:off x="186" y="8833"/>
                <a:ext cx="650" cy="5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12</a:t>
                </a:r>
              </a:p>
            </p:txBody>
          </p:sp>
        </p:grpSp>
        <p:grpSp>
          <p:nvGrpSpPr>
            <p:cNvPr id="6" name="组合 5"/>
            <p:cNvGrpSpPr/>
            <p:nvPr/>
          </p:nvGrpSpPr>
          <p:grpSpPr>
            <a:xfrm>
              <a:off x="192" y="5197"/>
              <a:ext cx="1134" cy="483"/>
              <a:chOff x="186" y="8850"/>
              <a:chExt cx="1134" cy="534"/>
            </a:xfrm>
          </p:grpSpPr>
          <p:cxnSp>
            <p:nvCxnSpPr>
              <p:cNvPr id="28" name="直接箭头连接符 27"/>
              <p:cNvCxnSpPr/>
              <p:nvPr/>
            </p:nvCxnSpPr>
            <p:spPr>
              <a:xfrm>
                <a:off x="720" y="8962"/>
                <a:ext cx="600" cy="0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" name="文本框 70"/>
              <p:cNvSpPr txBox="1"/>
              <p:nvPr/>
            </p:nvSpPr>
            <p:spPr>
              <a:xfrm>
                <a:off x="186" y="8850"/>
                <a:ext cx="650" cy="5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17</a:t>
                </a:r>
              </a:p>
            </p:txBody>
          </p:sp>
        </p:grpSp>
        <p:grpSp>
          <p:nvGrpSpPr>
            <p:cNvPr id="7" name="组合 6"/>
            <p:cNvGrpSpPr/>
            <p:nvPr/>
          </p:nvGrpSpPr>
          <p:grpSpPr>
            <a:xfrm>
              <a:off x="199" y="4514"/>
              <a:ext cx="1134" cy="483"/>
              <a:chOff x="186" y="8853"/>
              <a:chExt cx="1134" cy="534"/>
            </a:xfrm>
          </p:grpSpPr>
          <p:cxnSp>
            <p:nvCxnSpPr>
              <p:cNvPr id="26" name="直接箭头连接符 25"/>
              <p:cNvCxnSpPr/>
              <p:nvPr/>
            </p:nvCxnSpPr>
            <p:spPr>
              <a:xfrm>
                <a:off x="720" y="8962"/>
                <a:ext cx="600" cy="0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" name="文本框 73"/>
              <p:cNvSpPr txBox="1"/>
              <p:nvPr/>
            </p:nvSpPr>
            <p:spPr>
              <a:xfrm>
                <a:off x="186" y="8853"/>
                <a:ext cx="650" cy="5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26</a:t>
                </a:r>
              </a:p>
            </p:txBody>
          </p:sp>
        </p:grpSp>
        <p:grpSp>
          <p:nvGrpSpPr>
            <p:cNvPr id="8" name="组合 7"/>
            <p:cNvGrpSpPr/>
            <p:nvPr/>
          </p:nvGrpSpPr>
          <p:grpSpPr>
            <a:xfrm>
              <a:off x="199" y="4142"/>
              <a:ext cx="1134" cy="483"/>
              <a:chOff x="186" y="8572"/>
              <a:chExt cx="1134" cy="534"/>
            </a:xfrm>
          </p:grpSpPr>
          <p:cxnSp>
            <p:nvCxnSpPr>
              <p:cNvPr id="24" name="直接箭头连接符 23"/>
              <p:cNvCxnSpPr/>
              <p:nvPr/>
            </p:nvCxnSpPr>
            <p:spPr>
              <a:xfrm>
                <a:off x="720" y="8698"/>
                <a:ext cx="600" cy="0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5" name="文本框 76"/>
              <p:cNvSpPr txBox="1"/>
              <p:nvPr/>
            </p:nvSpPr>
            <p:spPr>
              <a:xfrm>
                <a:off x="186" y="8572"/>
                <a:ext cx="650" cy="5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34</a:t>
                </a:r>
              </a:p>
            </p:txBody>
          </p:sp>
        </p:grpSp>
        <p:grpSp>
          <p:nvGrpSpPr>
            <p:cNvPr id="9" name="组合 8"/>
            <p:cNvGrpSpPr/>
            <p:nvPr/>
          </p:nvGrpSpPr>
          <p:grpSpPr>
            <a:xfrm>
              <a:off x="240" y="3832"/>
              <a:ext cx="1086" cy="483"/>
              <a:chOff x="234" y="8593"/>
              <a:chExt cx="1086" cy="534"/>
            </a:xfrm>
          </p:grpSpPr>
          <p:cxnSp>
            <p:nvCxnSpPr>
              <p:cNvPr id="22" name="直接箭头连接符 21"/>
              <p:cNvCxnSpPr/>
              <p:nvPr/>
            </p:nvCxnSpPr>
            <p:spPr>
              <a:xfrm>
                <a:off x="720" y="8698"/>
                <a:ext cx="600" cy="0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" name="文本框 79"/>
              <p:cNvSpPr txBox="1"/>
              <p:nvPr/>
            </p:nvSpPr>
            <p:spPr>
              <a:xfrm>
                <a:off x="234" y="8593"/>
                <a:ext cx="650" cy="5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43</a:t>
                </a:r>
              </a:p>
            </p:txBody>
          </p:sp>
        </p:grpSp>
        <p:grpSp>
          <p:nvGrpSpPr>
            <p:cNvPr id="10" name="组合 9"/>
            <p:cNvGrpSpPr/>
            <p:nvPr/>
          </p:nvGrpSpPr>
          <p:grpSpPr>
            <a:xfrm>
              <a:off x="240" y="3598"/>
              <a:ext cx="1093" cy="483"/>
              <a:chOff x="227" y="8694"/>
              <a:chExt cx="1093" cy="534"/>
            </a:xfrm>
          </p:grpSpPr>
          <p:cxnSp>
            <p:nvCxnSpPr>
              <p:cNvPr id="20" name="直接箭头连接符 19"/>
              <p:cNvCxnSpPr/>
              <p:nvPr/>
            </p:nvCxnSpPr>
            <p:spPr>
              <a:xfrm>
                <a:off x="720" y="8830"/>
                <a:ext cx="600" cy="0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" name="文本框 82"/>
              <p:cNvSpPr txBox="1"/>
              <p:nvPr/>
            </p:nvSpPr>
            <p:spPr>
              <a:xfrm>
                <a:off x="227" y="8694"/>
                <a:ext cx="650" cy="5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55</a:t>
                </a:r>
              </a:p>
            </p:txBody>
          </p:sp>
        </p:grpSp>
        <p:grpSp>
          <p:nvGrpSpPr>
            <p:cNvPr id="11" name="组合 10"/>
            <p:cNvGrpSpPr/>
            <p:nvPr/>
          </p:nvGrpSpPr>
          <p:grpSpPr>
            <a:xfrm>
              <a:off x="240" y="3374"/>
              <a:ext cx="1093" cy="483"/>
              <a:chOff x="227" y="8813"/>
              <a:chExt cx="1093" cy="534"/>
            </a:xfrm>
          </p:grpSpPr>
          <p:cxnSp>
            <p:nvCxnSpPr>
              <p:cNvPr id="18" name="直接箭头连接符 17"/>
              <p:cNvCxnSpPr/>
              <p:nvPr/>
            </p:nvCxnSpPr>
            <p:spPr>
              <a:xfrm>
                <a:off x="720" y="8962"/>
                <a:ext cx="600" cy="0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文本框 85"/>
              <p:cNvSpPr txBox="1"/>
              <p:nvPr/>
            </p:nvSpPr>
            <p:spPr>
              <a:xfrm>
                <a:off x="227" y="8813"/>
                <a:ext cx="650" cy="5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72</a:t>
                </a:r>
              </a:p>
            </p:txBody>
          </p:sp>
        </p:grpSp>
        <p:grpSp>
          <p:nvGrpSpPr>
            <p:cNvPr id="12" name="组合 11"/>
            <p:cNvGrpSpPr/>
            <p:nvPr/>
          </p:nvGrpSpPr>
          <p:grpSpPr>
            <a:xfrm>
              <a:off x="220" y="3157"/>
              <a:ext cx="1120" cy="483"/>
              <a:chOff x="200" y="8872"/>
              <a:chExt cx="1120" cy="534"/>
            </a:xfrm>
          </p:grpSpPr>
          <p:cxnSp>
            <p:nvCxnSpPr>
              <p:cNvPr id="16" name="直接箭头连接符 15"/>
              <p:cNvCxnSpPr/>
              <p:nvPr/>
            </p:nvCxnSpPr>
            <p:spPr>
              <a:xfrm>
                <a:off x="720" y="9023"/>
                <a:ext cx="600" cy="0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" name="文本框 88"/>
              <p:cNvSpPr txBox="1"/>
              <p:nvPr/>
            </p:nvSpPr>
            <p:spPr>
              <a:xfrm>
                <a:off x="200" y="8872"/>
                <a:ext cx="783" cy="5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/>
                  <a:t>95</a:t>
                </a:r>
              </a:p>
            </p:txBody>
          </p:sp>
        </p:grpSp>
        <p:grpSp>
          <p:nvGrpSpPr>
            <p:cNvPr id="13" name="组合 12"/>
            <p:cNvGrpSpPr/>
            <p:nvPr/>
          </p:nvGrpSpPr>
          <p:grpSpPr>
            <a:xfrm>
              <a:off x="107" y="2964"/>
              <a:ext cx="1286" cy="483"/>
              <a:chOff x="101" y="8933"/>
              <a:chExt cx="1286" cy="534"/>
            </a:xfrm>
          </p:grpSpPr>
          <p:cxnSp>
            <p:nvCxnSpPr>
              <p:cNvPr id="14" name="直接箭头连接符 13"/>
              <p:cNvCxnSpPr/>
              <p:nvPr/>
            </p:nvCxnSpPr>
            <p:spPr>
              <a:xfrm>
                <a:off x="787" y="9069"/>
                <a:ext cx="600" cy="0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" name="文本框 91"/>
              <p:cNvSpPr txBox="1"/>
              <p:nvPr/>
            </p:nvSpPr>
            <p:spPr>
              <a:xfrm>
                <a:off x="101" y="8933"/>
                <a:ext cx="783" cy="5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110</a:t>
                </a:r>
              </a:p>
            </p:txBody>
          </p:sp>
        </p:grpSp>
      </p:grpSp>
      <p:pic>
        <p:nvPicPr>
          <p:cNvPr id="32" name="图片 3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4031" y="1587850"/>
            <a:ext cx="6929579" cy="4482312"/>
          </a:xfrm>
          <a:prstGeom prst="rect">
            <a:avLst/>
          </a:prstGeom>
        </p:spPr>
      </p:pic>
      <p:sp>
        <p:nvSpPr>
          <p:cNvPr id="33" name="文本框 46"/>
          <p:cNvSpPr txBox="1"/>
          <p:nvPr/>
        </p:nvSpPr>
        <p:spPr>
          <a:xfrm>
            <a:off x="8028384" y="2204864"/>
            <a:ext cx="1008112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solidFill>
                  <a:srgbClr val="FF0000"/>
                </a:solidFill>
                <a:sym typeface="+mn-ea"/>
              </a:rPr>
              <a:t>ATG7</a:t>
            </a:r>
          </a:p>
        </p:txBody>
      </p:sp>
      <p:sp>
        <p:nvSpPr>
          <p:cNvPr id="34" name="文本框 43"/>
          <p:cNvSpPr txBox="1"/>
          <p:nvPr/>
        </p:nvSpPr>
        <p:spPr>
          <a:xfrm>
            <a:off x="2640984" y="1052736"/>
            <a:ext cx="8782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err="1" smtClean="0"/>
              <a:t>HeLa</a:t>
            </a:r>
            <a:endParaRPr lang="en-US" altLang="zh-CN" sz="2000" b="1" dirty="0"/>
          </a:p>
        </p:txBody>
      </p:sp>
      <p:sp>
        <p:nvSpPr>
          <p:cNvPr id="35" name="文本框 44"/>
          <p:cNvSpPr txBox="1"/>
          <p:nvPr/>
        </p:nvSpPr>
        <p:spPr>
          <a:xfrm>
            <a:off x="5868144" y="1052736"/>
            <a:ext cx="78105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err="1" smtClean="0"/>
              <a:t>SiHa</a:t>
            </a:r>
            <a:endParaRPr lang="en-US" altLang="zh-CN" sz="2000" b="1" dirty="0"/>
          </a:p>
        </p:txBody>
      </p:sp>
      <p:cxnSp>
        <p:nvCxnSpPr>
          <p:cNvPr id="44" name="直接箭头连接符 43"/>
          <p:cNvCxnSpPr/>
          <p:nvPr/>
        </p:nvCxnSpPr>
        <p:spPr>
          <a:xfrm flipH="1" flipV="1">
            <a:off x="7596336" y="2420888"/>
            <a:ext cx="403225" cy="1270"/>
          </a:xfrm>
          <a:prstGeom prst="straightConnector1">
            <a:avLst/>
          </a:prstGeom>
          <a:ln w="38100">
            <a:solidFill>
              <a:srgbClr val="FF0000"/>
            </a:solidFill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5" name="标题 1"/>
          <p:cNvSpPr>
            <a:spLocks noGrp="1"/>
          </p:cNvSpPr>
          <p:nvPr/>
        </p:nvSpPr>
        <p:spPr>
          <a:xfrm>
            <a:off x="6948264" y="6183079"/>
            <a:ext cx="1266825" cy="3422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575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3200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3200" dirty="0" smtClean="0">
                <a:latin typeface="Times New Roman" pitchFamily="18" charset="0"/>
                <a:cs typeface="Times New Roman" pitchFamily="18" charset="0"/>
              </a:rPr>
              <a:t>5D</a:t>
            </a:r>
            <a:endParaRPr lang="en-US" altLang="zh-CN" sz="3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文本框 42"/>
          <p:cNvSpPr txBox="1"/>
          <p:nvPr/>
        </p:nvSpPr>
        <p:spPr>
          <a:xfrm rot="16200000">
            <a:off x="1728950" y="2927735"/>
            <a:ext cx="9201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  <a:sym typeface="+mn-ea"/>
              </a:rPr>
              <a:t>Control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文本框 42"/>
          <p:cNvSpPr txBox="1"/>
          <p:nvPr/>
        </p:nvSpPr>
        <p:spPr>
          <a:xfrm rot="16200000">
            <a:off x="2457763" y="3430069"/>
            <a:ext cx="1924867" cy="3385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  <a:sym typeface="+mn-ea"/>
              </a:rPr>
              <a:t>Ast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  <a:sym typeface="+mn-ea"/>
              </a:rPr>
              <a:t>. +DCP1AsiRNA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文本框 42"/>
          <p:cNvSpPr txBox="1"/>
          <p:nvPr/>
        </p:nvSpPr>
        <p:spPr>
          <a:xfrm rot="16200000">
            <a:off x="2460301" y="2804396"/>
            <a:ext cx="529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  <a:sym typeface="+mn-ea"/>
              </a:rPr>
              <a:t>Ast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  <a:sym typeface="+mn-ea"/>
              </a:rPr>
              <a:t>.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文本框 42"/>
          <p:cNvSpPr txBox="1"/>
          <p:nvPr/>
        </p:nvSpPr>
        <p:spPr>
          <a:xfrm rot="16200000">
            <a:off x="3018634" y="3439427"/>
            <a:ext cx="20875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  <a:sym typeface="+mn-ea"/>
              </a:rPr>
              <a:t>Ast.+TMSB4XsiRNA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文本框 42"/>
          <p:cNvSpPr txBox="1"/>
          <p:nvPr/>
        </p:nvSpPr>
        <p:spPr>
          <a:xfrm rot="16200000">
            <a:off x="4857242" y="2855727"/>
            <a:ext cx="9201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  <a:sym typeface="+mn-ea"/>
              </a:rPr>
              <a:t>Control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文本框 42"/>
          <p:cNvSpPr txBox="1"/>
          <p:nvPr/>
        </p:nvSpPr>
        <p:spPr>
          <a:xfrm rot="16200000">
            <a:off x="5586055" y="3358061"/>
            <a:ext cx="1924867" cy="3385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  <a:sym typeface="+mn-ea"/>
              </a:rPr>
              <a:t>Ast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  <a:sym typeface="+mn-ea"/>
              </a:rPr>
              <a:t>. +DCP1AsiRNA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文本框 42"/>
          <p:cNvSpPr txBox="1"/>
          <p:nvPr/>
        </p:nvSpPr>
        <p:spPr>
          <a:xfrm rot="16200000">
            <a:off x="5588593" y="2732388"/>
            <a:ext cx="529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  <a:sym typeface="+mn-ea"/>
              </a:rPr>
              <a:t>Ast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  <a:sym typeface="+mn-ea"/>
              </a:rPr>
              <a:t>.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文本框 42"/>
          <p:cNvSpPr txBox="1"/>
          <p:nvPr/>
        </p:nvSpPr>
        <p:spPr>
          <a:xfrm rot="16200000">
            <a:off x="6146926" y="3367419"/>
            <a:ext cx="20875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  <a:sym typeface="+mn-ea"/>
              </a:rPr>
              <a:t>Ast.+TMSB4XsiRNA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4" name="直接连接符 53"/>
          <p:cNvCxnSpPr/>
          <p:nvPr/>
        </p:nvCxnSpPr>
        <p:spPr>
          <a:xfrm flipV="1">
            <a:off x="1351026" y="1483514"/>
            <a:ext cx="3095741" cy="127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/>
        </p:nvCxnSpPr>
        <p:spPr>
          <a:xfrm flipV="1">
            <a:off x="4716619" y="1483514"/>
            <a:ext cx="3095741" cy="127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568465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951" y="576263"/>
            <a:ext cx="8895647" cy="58770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653215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500" y="387350"/>
            <a:ext cx="9017000" cy="6089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985812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163" y="579438"/>
            <a:ext cx="8828087" cy="5707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736189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383" y="607777"/>
            <a:ext cx="8770783" cy="56424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22803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147</Words>
  <Application>Microsoft Office PowerPoint</Application>
  <PresentationFormat>全屏显示(4:3)</PresentationFormat>
  <Paragraphs>36</Paragraphs>
  <Slides>1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5" baseType="lpstr">
      <vt:lpstr>Office 主题</vt:lpstr>
      <vt:lpstr>Supplementary for Western Blo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Supplementary for Methods</vt:lpstr>
      <vt:lpstr>PowerPoint 演示文稿</vt:lpstr>
      <vt:lpstr>PowerPoint 演示文稿</vt:lpstr>
      <vt:lpstr>Supplementary for PRM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Xia</cp:lastModifiedBy>
  <cp:revision>38</cp:revision>
  <dcterms:created xsi:type="dcterms:W3CDTF">2019-11-20T08:04:00Z</dcterms:created>
  <dcterms:modified xsi:type="dcterms:W3CDTF">2020-02-26T12:46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45</vt:lpwstr>
  </property>
</Properties>
</file>